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494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83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37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607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731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265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1329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705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164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0756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197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844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168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图片 5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5254" y="754434"/>
            <a:ext cx="4052455" cy="5572126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2933780" y="1427510"/>
            <a:ext cx="68480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618584" y="3918077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7453263" y="4265272"/>
            <a:ext cx="585417" cy="276999"/>
            <a:chOff x="-5704713" y="6919617"/>
            <a:chExt cx="585417" cy="276999"/>
          </a:xfrm>
        </p:grpSpPr>
        <p:sp>
          <p:nvSpPr>
            <p:cNvPr id="28" name="矩形 27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" name="组合 29"/>
          <p:cNvGrpSpPr/>
          <p:nvPr/>
        </p:nvGrpSpPr>
        <p:grpSpPr>
          <a:xfrm>
            <a:off x="7453263" y="4947827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7453263" y="4681117"/>
            <a:ext cx="585417" cy="276999"/>
            <a:chOff x="-5704713" y="6919617"/>
            <a:chExt cx="585417" cy="276999"/>
          </a:xfrm>
        </p:grpSpPr>
        <p:sp>
          <p:nvSpPr>
            <p:cNvPr id="39" name="矩形 38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3" name="组合 32"/>
          <p:cNvGrpSpPr/>
          <p:nvPr/>
        </p:nvGrpSpPr>
        <p:grpSpPr>
          <a:xfrm>
            <a:off x="4950345" y="3355831"/>
            <a:ext cx="2698243" cy="978864"/>
            <a:chOff x="10718622" y="5109925"/>
            <a:chExt cx="2698243" cy="978864"/>
          </a:xfrm>
        </p:grpSpPr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7AB8D627-2A21-4984-B8FE-C2200BA2F303}"/>
                </a:ext>
              </a:extLst>
            </p:cNvPr>
            <p:cNvCxnSpPr>
              <a:cxnSpLocks/>
            </p:cNvCxnSpPr>
            <p:nvPr/>
          </p:nvCxnSpPr>
          <p:spPr>
            <a:xfrm>
              <a:off x="10880780" y="5479257"/>
              <a:ext cx="2160000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AF07C899-B814-497A-99A6-DC5DD0AFDC89}"/>
                </a:ext>
              </a:extLst>
            </p:cNvPr>
            <p:cNvSpPr/>
            <p:nvPr/>
          </p:nvSpPr>
          <p:spPr>
            <a:xfrm>
              <a:off x="11174096" y="5109925"/>
              <a:ext cx="156867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59775DCD-6CFA-43ED-9FF0-1A4E09A241E0}"/>
                </a:ext>
              </a:extLst>
            </p:cNvPr>
            <p:cNvSpPr/>
            <p:nvPr/>
          </p:nvSpPr>
          <p:spPr>
            <a:xfrm>
              <a:off x="11838799" y="5750235"/>
              <a:ext cx="28804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92A08E4B-5257-4107-945D-E8CB870B880B}"/>
                </a:ext>
              </a:extLst>
            </p:cNvPr>
            <p:cNvSpPr/>
            <p:nvPr/>
          </p:nvSpPr>
          <p:spPr>
            <a:xfrm>
              <a:off x="12108025" y="5750235"/>
              <a:ext cx="25149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30DFDF9C-2646-41C9-806B-4EAB05AE0190}"/>
                </a:ext>
              </a:extLst>
            </p:cNvPr>
            <p:cNvCxnSpPr>
              <a:cxnSpLocks/>
            </p:cNvCxnSpPr>
            <p:nvPr/>
          </p:nvCxnSpPr>
          <p:spPr>
            <a:xfrm>
              <a:off x="11641406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563551E6-C6CC-4328-8CDD-AE4414201BC4}"/>
                </a:ext>
              </a:extLst>
            </p:cNvPr>
            <p:cNvSpPr/>
            <p:nvPr/>
          </p:nvSpPr>
          <p:spPr>
            <a:xfrm>
              <a:off x="11581828" y="5750235"/>
              <a:ext cx="27295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C387E3E4-A1C6-42CC-A6C5-0BA7F0E14E3F}"/>
                </a:ext>
              </a:extLst>
            </p:cNvPr>
            <p:cNvSpPr/>
            <p:nvPr/>
          </p:nvSpPr>
          <p:spPr>
            <a:xfrm>
              <a:off x="11427375" y="5447848"/>
              <a:ext cx="107513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17A4B306-11B8-4BFB-AB99-43EABAEFF1D6}"/>
                </a:ext>
              </a:extLst>
            </p:cNvPr>
            <p:cNvSpPr/>
            <p:nvPr/>
          </p:nvSpPr>
          <p:spPr>
            <a:xfrm>
              <a:off x="12638568" y="5750235"/>
              <a:ext cx="27954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C788145C-1E4E-4D58-A39C-3EC8676456E2}"/>
                </a:ext>
              </a:extLst>
            </p:cNvPr>
            <p:cNvSpPr/>
            <p:nvPr/>
          </p:nvSpPr>
          <p:spPr>
            <a:xfrm>
              <a:off x="12895094" y="5750235"/>
              <a:ext cx="21246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8083B74A-9EC6-4800-A29C-A1638B241943}"/>
                </a:ext>
              </a:extLst>
            </p:cNvPr>
            <p:cNvCxnSpPr>
              <a:cxnSpLocks/>
            </p:cNvCxnSpPr>
            <p:nvPr/>
          </p:nvCxnSpPr>
          <p:spPr>
            <a:xfrm>
              <a:off x="12403075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B375E51B-A7C4-4085-AF1A-965C660D95FC}"/>
                </a:ext>
              </a:extLst>
            </p:cNvPr>
            <p:cNvSpPr/>
            <p:nvPr/>
          </p:nvSpPr>
          <p:spPr>
            <a:xfrm>
              <a:off x="12375246" y="5750235"/>
              <a:ext cx="25837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676FA9AB-C77A-4420-9219-9AF2FC0C4340}"/>
                </a:ext>
              </a:extLst>
            </p:cNvPr>
            <p:cNvSpPr/>
            <p:nvPr/>
          </p:nvSpPr>
          <p:spPr>
            <a:xfrm>
              <a:off x="12236013" y="5441683"/>
              <a:ext cx="118085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42B35119-B9EE-4AF2-9C45-5B685CC0C9E3}"/>
                </a:ext>
              </a:extLst>
            </p:cNvPr>
            <p:cNvSpPr/>
            <p:nvPr/>
          </p:nvSpPr>
          <p:spPr>
            <a:xfrm>
              <a:off x="11035073" y="5750235"/>
              <a:ext cx="30069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0EC1130D-43C4-41DB-9FE0-304760C7E91C}"/>
                </a:ext>
              </a:extLst>
            </p:cNvPr>
            <p:cNvSpPr/>
            <p:nvPr/>
          </p:nvSpPr>
          <p:spPr>
            <a:xfrm>
              <a:off x="11323384" y="5750235"/>
              <a:ext cx="26512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DE2E1CD7-BD3A-4B2B-99A9-6EF43FCA7554}"/>
                </a:ext>
              </a:extLst>
            </p:cNvPr>
            <p:cNvCxnSpPr>
              <a:cxnSpLocks/>
            </p:cNvCxnSpPr>
            <p:nvPr/>
          </p:nvCxnSpPr>
          <p:spPr>
            <a:xfrm>
              <a:off x="10863203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F22FC5F6-59DD-45B6-968B-4259F26ACF22}"/>
                </a:ext>
              </a:extLst>
            </p:cNvPr>
            <p:cNvSpPr/>
            <p:nvPr/>
          </p:nvSpPr>
          <p:spPr>
            <a:xfrm>
              <a:off x="10797275" y="5750235"/>
              <a:ext cx="25952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27B801F5-F343-43AA-96DD-C266A6B328B9}"/>
                </a:ext>
              </a:extLst>
            </p:cNvPr>
            <p:cNvSpPr/>
            <p:nvPr/>
          </p:nvSpPr>
          <p:spPr>
            <a:xfrm>
              <a:off x="10718622" y="5454803"/>
              <a:ext cx="976833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ctr"/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矩形 40"/>
          <p:cNvSpPr/>
          <p:nvPr/>
        </p:nvSpPr>
        <p:spPr>
          <a:xfrm>
            <a:off x="5006473" y="4243188"/>
            <a:ext cx="2544644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029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5359" y="208493"/>
            <a:ext cx="3943841" cy="5422781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059870A5-3417-43F5-A795-482DC7036A0F}"/>
              </a:ext>
            </a:extLst>
          </p:cNvPr>
          <p:cNvSpPr/>
          <p:nvPr/>
        </p:nvSpPr>
        <p:spPr>
          <a:xfrm>
            <a:off x="2435277" y="1144161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157398" y="3583605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8138946" y="3898748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/>
          <p:cNvGrpSpPr/>
          <p:nvPr/>
        </p:nvGrpSpPr>
        <p:grpSpPr>
          <a:xfrm>
            <a:off x="8160460" y="4410649"/>
            <a:ext cx="585417" cy="276999"/>
            <a:chOff x="-5704713" y="6919617"/>
            <a:chExt cx="585417" cy="276999"/>
          </a:xfrm>
        </p:grpSpPr>
        <p:sp>
          <p:nvSpPr>
            <p:cNvPr id="53" name="矩形 52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" name="组合 1"/>
          <p:cNvGrpSpPr/>
          <p:nvPr/>
        </p:nvGrpSpPr>
        <p:grpSpPr>
          <a:xfrm>
            <a:off x="4425359" y="2919884"/>
            <a:ext cx="2698243" cy="978864"/>
            <a:chOff x="10718622" y="5109925"/>
            <a:chExt cx="2698243" cy="978864"/>
          </a:xfrm>
        </p:grpSpPr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7AB8D627-2A21-4984-B8FE-C2200BA2F303}"/>
                </a:ext>
              </a:extLst>
            </p:cNvPr>
            <p:cNvCxnSpPr>
              <a:cxnSpLocks/>
            </p:cNvCxnSpPr>
            <p:nvPr/>
          </p:nvCxnSpPr>
          <p:spPr>
            <a:xfrm>
              <a:off x="10880780" y="5479257"/>
              <a:ext cx="2160000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AF07C899-B814-497A-99A6-DC5DD0AFDC89}"/>
                </a:ext>
              </a:extLst>
            </p:cNvPr>
            <p:cNvSpPr/>
            <p:nvPr/>
          </p:nvSpPr>
          <p:spPr>
            <a:xfrm>
              <a:off x="11174096" y="5109925"/>
              <a:ext cx="156867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PDAC-CN1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59775DCD-6CFA-43ED-9FF0-1A4E09A241E0}"/>
                </a:ext>
              </a:extLst>
            </p:cNvPr>
            <p:cNvSpPr/>
            <p:nvPr/>
          </p:nvSpPr>
          <p:spPr>
            <a:xfrm>
              <a:off x="11838799" y="5750235"/>
              <a:ext cx="28804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92A08E4B-5257-4107-945D-E8CB870B880B}"/>
                </a:ext>
              </a:extLst>
            </p:cNvPr>
            <p:cNvSpPr/>
            <p:nvPr/>
          </p:nvSpPr>
          <p:spPr>
            <a:xfrm>
              <a:off x="12108025" y="5750235"/>
              <a:ext cx="25149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30DFDF9C-2646-41C9-806B-4EAB05AE0190}"/>
                </a:ext>
              </a:extLst>
            </p:cNvPr>
            <p:cNvCxnSpPr>
              <a:cxnSpLocks/>
            </p:cNvCxnSpPr>
            <p:nvPr/>
          </p:nvCxnSpPr>
          <p:spPr>
            <a:xfrm>
              <a:off x="11641406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563551E6-C6CC-4328-8CDD-AE4414201BC4}"/>
                </a:ext>
              </a:extLst>
            </p:cNvPr>
            <p:cNvSpPr/>
            <p:nvPr/>
          </p:nvSpPr>
          <p:spPr>
            <a:xfrm>
              <a:off x="11581828" y="5750235"/>
              <a:ext cx="27295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C387E3E4-A1C6-42CC-A6C5-0BA7F0E14E3F}"/>
                </a:ext>
              </a:extLst>
            </p:cNvPr>
            <p:cNvSpPr/>
            <p:nvPr/>
          </p:nvSpPr>
          <p:spPr>
            <a:xfrm>
              <a:off x="11427375" y="5447848"/>
              <a:ext cx="107513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17A4B306-11B8-4BFB-AB99-43EABAEFF1D6}"/>
                </a:ext>
              </a:extLst>
            </p:cNvPr>
            <p:cNvSpPr/>
            <p:nvPr/>
          </p:nvSpPr>
          <p:spPr>
            <a:xfrm>
              <a:off x="12638568" y="5750235"/>
              <a:ext cx="27954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C788145C-1E4E-4D58-A39C-3EC8676456E2}"/>
                </a:ext>
              </a:extLst>
            </p:cNvPr>
            <p:cNvSpPr/>
            <p:nvPr/>
          </p:nvSpPr>
          <p:spPr>
            <a:xfrm>
              <a:off x="12895094" y="5750235"/>
              <a:ext cx="21246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8083B74A-9EC6-4800-A29C-A1638B241943}"/>
                </a:ext>
              </a:extLst>
            </p:cNvPr>
            <p:cNvCxnSpPr>
              <a:cxnSpLocks/>
            </p:cNvCxnSpPr>
            <p:nvPr/>
          </p:nvCxnSpPr>
          <p:spPr>
            <a:xfrm>
              <a:off x="12403075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B375E51B-A7C4-4085-AF1A-965C660D95FC}"/>
                </a:ext>
              </a:extLst>
            </p:cNvPr>
            <p:cNvSpPr/>
            <p:nvPr/>
          </p:nvSpPr>
          <p:spPr>
            <a:xfrm>
              <a:off x="12375246" y="5750235"/>
              <a:ext cx="25837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676FA9AB-C77A-4420-9219-9AF2FC0C4340}"/>
                </a:ext>
              </a:extLst>
            </p:cNvPr>
            <p:cNvSpPr/>
            <p:nvPr/>
          </p:nvSpPr>
          <p:spPr>
            <a:xfrm>
              <a:off x="12236013" y="5441683"/>
              <a:ext cx="118085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42B35119-B9EE-4AF2-9C45-5B685CC0C9E3}"/>
                </a:ext>
              </a:extLst>
            </p:cNvPr>
            <p:cNvSpPr/>
            <p:nvPr/>
          </p:nvSpPr>
          <p:spPr>
            <a:xfrm>
              <a:off x="11035073" y="5750235"/>
              <a:ext cx="30069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0EC1130D-43C4-41DB-9FE0-304760C7E91C}"/>
                </a:ext>
              </a:extLst>
            </p:cNvPr>
            <p:cNvSpPr/>
            <p:nvPr/>
          </p:nvSpPr>
          <p:spPr>
            <a:xfrm>
              <a:off x="11323384" y="5750235"/>
              <a:ext cx="26512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DE2E1CD7-BD3A-4B2B-99A9-6EF43FCA7554}"/>
                </a:ext>
              </a:extLst>
            </p:cNvPr>
            <p:cNvCxnSpPr>
              <a:cxnSpLocks/>
            </p:cNvCxnSpPr>
            <p:nvPr/>
          </p:nvCxnSpPr>
          <p:spPr>
            <a:xfrm>
              <a:off x="10863203" y="5736970"/>
              <a:ext cx="687673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F22FC5F6-59DD-45B6-968B-4259F26ACF22}"/>
                </a:ext>
              </a:extLst>
            </p:cNvPr>
            <p:cNvSpPr/>
            <p:nvPr/>
          </p:nvSpPr>
          <p:spPr>
            <a:xfrm>
              <a:off x="10797275" y="5750235"/>
              <a:ext cx="259524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27B801F5-F343-43AA-96DD-C266A6B328B9}"/>
                </a:ext>
              </a:extLst>
            </p:cNvPr>
            <p:cNvSpPr/>
            <p:nvPr/>
          </p:nvSpPr>
          <p:spPr>
            <a:xfrm>
              <a:off x="10718622" y="5454803"/>
              <a:ext cx="976833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矩形 47"/>
          <p:cNvSpPr/>
          <p:nvPr/>
        </p:nvSpPr>
        <p:spPr>
          <a:xfrm>
            <a:off x="4421625" y="3842217"/>
            <a:ext cx="2544644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66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2</Words>
  <Application>Microsoft Office PowerPoint</Application>
  <PresentationFormat>宽屏</PresentationFormat>
  <Paragraphs>3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7</cp:revision>
  <dcterms:created xsi:type="dcterms:W3CDTF">2024-02-08T06:32:19Z</dcterms:created>
  <dcterms:modified xsi:type="dcterms:W3CDTF">2024-02-12T00:31:34Z</dcterms:modified>
</cp:coreProperties>
</file>